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Default Extension="tiff" ContentType="image/tiff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40" d="100"/>
          <a:sy n="140" d="100"/>
        </p:scale>
        <p:origin x="-1956" y="331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D223E-8C89-4DAD-B8B1-0AD3D64EC221}" type="datetimeFigureOut">
              <a:rPr lang="fr-FR" smtClean="0"/>
              <a:t>01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0D5B2-65C1-44DF-A764-6EB03F8E0F6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652493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D223E-8C89-4DAD-B8B1-0AD3D64EC221}" type="datetimeFigureOut">
              <a:rPr lang="fr-FR" smtClean="0"/>
              <a:t>01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0D5B2-65C1-44DF-A764-6EB03F8E0F6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734863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D223E-8C89-4DAD-B8B1-0AD3D64EC221}" type="datetimeFigureOut">
              <a:rPr lang="fr-FR" smtClean="0"/>
              <a:t>01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0D5B2-65C1-44DF-A764-6EB03F8E0F6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551180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D223E-8C89-4DAD-B8B1-0AD3D64EC221}" type="datetimeFigureOut">
              <a:rPr lang="fr-FR" smtClean="0"/>
              <a:t>01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0D5B2-65C1-44DF-A764-6EB03F8E0F6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943550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D223E-8C89-4DAD-B8B1-0AD3D64EC221}" type="datetimeFigureOut">
              <a:rPr lang="fr-FR" smtClean="0"/>
              <a:t>01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0D5B2-65C1-44DF-A764-6EB03F8E0F6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804495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D223E-8C89-4DAD-B8B1-0AD3D64EC221}" type="datetimeFigureOut">
              <a:rPr lang="fr-FR" smtClean="0"/>
              <a:t>01/07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0D5B2-65C1-44DF-A764-6EB03F8E0F6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659598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D223E-8C89-4DAD-B8B1-0AD3D64EC221}" type="datetimeFigureOut">
              <a:rPr lang="fr-FR" smtClean="0"/>
              <a:t>01/07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0D5B2-65C1-44DF-A764-6EB03F8E0F6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020755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D223E-8C89-4DAD-B8B1-0AD3D64EC221}" type="datetimeFigureOut">
              <a:rPr lang="fr-FR" smtClean="0"/>
              <a:t>01/07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0D5B2-65C1-44DF-A764-6EB03F8E0F6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653175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D223E-8C89-4DAD-B8B1-0AD3D64EC221}" type="datetimeFigureOut">
              <a:rPr lang="fr-FR" smtClean="0"/>
              <a:t>01/07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0D5B2-65C1-44DF-A764-6EB03F8E0F6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883640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D223E-8C89-4DAD-B8B1-0AD3D64EC221}" type="datetimeFigureOut">
              <a:rPr lang="fr-FR" smtClean="0"/>
              <a:t>01/07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0D5B2-65C1-44DF-A764-6EB03F8E0F6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587011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D223E-8C89-4DAD-B8B1-0AD3D64EC221}" type="datetimeFigureOut">
              <a:rPr lang="fr-FR" smtClean="0"/>
              <a:t>01/07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0D5B2-65C1-44DF-A764-6EB03F8E0F6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925320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BD223E-8C89-4DAD-B8B1-0AD3D64EC221}" type="datetimeFigureOut">
              <a:rPr lang="fr-FR" smtClean="0"/>
              <a:t>01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D0D5B2-65C1-44DF-A764-6EB03F8E0F6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083254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Z:\06_publications_pvpp\articles_en_cours_d_ecriture\pubAXgrainMaïs\Microscopie controle Lapin21\2JAF-Lp21-FLx20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87860" y="483394"/>
            <a:ext cx="18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ZoneTexte 1"/>
          <p:cNvSpPr txBox="1"/>
          <p:nvPr/>
        </p:nvSpPr>
        <p:spPr>
          <a:xfrm>
            <a:off x="1211324" y="186070"/>
            <a:ext cx="15841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1 0 DAP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7" name="Picture 3" descr="Z:\06_publications_pvpp\articles_en_cours_d_ecriture\pubAXgrainMaïs\Microscopie controle Lapin21\15JAF-Lp21-FLx20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47294" y="483766"/>
            <a:ext cx="18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ZoneTexte 4"/>
          <p:cNvSpPr txBox="1"/>
          <p:nvPr/>
        </p:nvSpPr>
        <p:spPr>
          <a:xfrm>
            <a:off x="4263118" y="186070"/>
            <a:ext cx="15841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3 18 DAP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8" name="Picture 4" descr="Z:\06_publications_pvpp\articles_en_cours_d_ecriture\pubAXgrainMaïs\Microscopie controle Lapin21\28JAF-Lp21-FLx20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6528" y="2854309"/>
            <a:ext cx="18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ZoneTexte 6"/>
          <p:cNvSpPr txBox="1"/>
          <p:nvPr/>
        </p:nvSpPr>
        <p:spPr>
          <a:xfrm>
            <a:off x="1189744" y="2510997"/>
            <a:ext cx="15841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5 30 DAP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9" name="Picture 5" descr="Z:\06_publications_pvpp\articles_en_cours_d_ecriture\pubAXgrainMaïs\Microscopie controle Lapin21\65JAF-Lp21-FLx20.ti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47294" y="2880329"/>
            <a:ext cx="18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ZoneTexte 8"/>
          <p:cNvSpPr txBox="1"/>
          <p:nvPr/>
        </p:nvSpPr>
        <p:spPr>
          <a:xfrm>
            <a:off x="4268054" y="2541135"/>
            <a:ext cx="15841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6 67 DAP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578444" y="7596336"/>
            <a:ext cx="5897216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fr-FR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ure 1. </a:t>
            </a:r>
            <a:r>
              <a:rPr lang="fr-FR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egative</a:t>
            </a:r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fr-FR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trols</a:t>
            </a:r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rresponding</a:t>
            </a:r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o the </a:t>
            </a:r>
            <a:r>
              <a:rPr lang="fr-FR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mmunolabeling</a:t>
            </a:r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eriments</a:t>
            </a:r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esented</a:t>
            </a:r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Figure </a:t>
            </a:r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  and Figure 6.</a:t>
            </a:r>
            <a:endParaRPr lang="fr-FR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L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gitudinal 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ctions of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ize</a:t>
            </a:r>
            <a:r>
              <a:rPr lang="fr-FR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ain 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 c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os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tions of maize primary root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cubated with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-immune serum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instead of 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ti-5-O-FerAra) and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en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ubated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ti-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abbit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condary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tibody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luorescence 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mages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ptured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sing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me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osure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onditions as the one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sed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or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mmunolabeling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ti-5-O-FerAra. </a:t>
            </a:r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ZoneTexte 10"/>
          <p:cNvSpPr txBox="1"/>
          <p:nvPr/>
        </p:nvSpPr>
        <p:spPr>
          <a:xfrm>
            <a:off x="288761" y="190489"/>
            <a:ext cx="5793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fr-F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ZoneTexte 11"/>
          <p:cNvSpPr txBox="1"/>
          <p:nvPr/>
        </p:nvSpPr>
        <p:spPr>
          <a:xfrm>
            <a:off x="301865" y="4850740"/>
            <a:ext cx="5793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fr-F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Image 12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8118"/>
          <a:stretch/>
        </p:blipFill>
        <p:spPr>
          <a:xfrm>
            <a:off x="980728" y="5396155"/>
            <a:ext cx="4758709" cy="1764000"/>
          </a:xfrm>
          <a:prstGeom prst="rect">
            <a:avLst/>
          </a:prstGeom>
        </p:spPr>
      </p:pic>
      <p:sp>
        <p:nvSpPr>
          <p:cNvPr id="14" name="ZoneTexte 13"/>
          <p:cNvSpPr txBox="1"/>
          <p:nvPr/>
        </p:nvSpPr>
        <p:spPr>
          <a:xfrm>
            <a:off x="1326000" y="5076056"/>
            <a:ext cx="19589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longation zone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ZoneTexte 14"/>
          <p:cNvSpPr txBox="1"/>
          <p:nvPr/>
        </p:nvSpPr>
        <p:spPr>
          <a:xfrm>
            <a:off x="3527052" y="5086220"/>
            <a:ext cx="23251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st-</a:t>
            </a:r>
            <a:r>
              <a:rPr lang="fr-FR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fr-FR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ngation</a:t>
            </a:r>
            <a:r>
              <a:rPr lang="fr-F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zone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377267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F3304DEAE09B24DA68D64CBB702879E" ma:contentTypeVersion="7" ma:contentTypeDescription="Create a new document." ma:contentTypeScope="" ma:versionID="56f4917bd8fe5572caa8ce3e64525f08">
  <xsd:schema xmlns:xsd="http://www.w3.org/2001/XMLSchema" xmlns:p="http://schemas.microsoft.com/office/2006/metadata/properties" xmlns:ns2="28de4f29-e3d9-478e-b05a-16a8ff0eb393" targetNamespace="http://schemas.microsoft.com/office/2006/metadata/properties" ma:root="true" ma:fieldsID="90fc53ae50983f9ac236714ed868e368" ns2:_="">
    <xsd:import namespace="28de4f29-e3d9-478e-b05a-16a8ff0eb393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28de4f29-e3d9-478e-b05a-16a8ff0eb393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Id xmlns="28de4f29-e3d9-478e-b05a-16a8ff0eb393">Presentation 1.PPTX</DocumentId>
    <StageName xmlns="28de4f29-e3d9-478e-b05a-16a8ff0eb393" xsi:nil="true"/>
    <IsDeleted xmlns="28de4f29-e3d9-478e-b05a-16a8ff0eb393">false</IsDeleted>
    <FileFormat xmlns="28de4f29-e3d9-478e-b05a-16a8ff0eb393">PPTX</FileFormat>
    <TitleName xmlns="28de4f29-e3d9-478e-b05a-16a8ff0eb393">Presentation 1.PPTX</TitleName>
    <DocumentType xmlns="28de4f29-e3d9-478e-b05a-16a8ff0eb393">Presentation</DocumentType>
    <Checked_x0020_Out_x0020_To xmlns="28de4f29-e3d9-478e-b05a-16a8ff0eb393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AE3122AC-4E7C-4F42-A1D4-334FA2A0494C}"/>
</file>

<file path=customXml/itemProps2.xml><?xml version="1.0" encoding="utf-8"?>
<ds:datastoreItem xmlns:ds="http://schemas.openxmlformats.org/officeDocument/2006/customXml" ds:itemID="{E5D881F9-3343-4771-A5D1-293020D5B0DA}"/>
</file>

<file path=customXml/itemProps3.xml><?xml version="1.0" encoding="utf-8"?>
<ds:datastoreItem xmlns:ds="http://schemas.openxmlformats.org/officeDocument/2006/customXml" ds:itemID="{992913FF-F824-4318-B7A9-49500D0BAC11}"/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91</Words>
  <Application>Microsoft Office PowerPoint</Application>
  <PresentationFormat>Affichage à l'écran 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INR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lchateigner</dc:creator>
  <cp:lastModifiedBy>alchateigner</cp:lastModifiedBy>
  <cp:revision>5</cp:revision>
  <dcterms:created xsi:type="dcterms:W3CDTF">2016-06-29T07:18:39Z</dcterms:created>
  <dcterms:modified xsi:type="dcterms:W3CDTF">2016-07-01T06:24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F3304DEAE09B24DA68D64CBB702879E</vt:lpwstr>
  </property>
</Properties>
</file>